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5"/>
    <p:restoredTop sz="94633"/>
  </p:normalViewPr>
  <p:slideViewPr>
    <p:cSldViewPr snapToGrid="0" snapToObjects="1" showGuides="1">
      <p:cViewPr varScale="1">
        <p:scale>
          <a:sx n="212" d="100"/>
          <a:sy n="212" d="100"/>
        </p:scale>
        <p:origin x="25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クリックして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58821CA2-E772-5645-9159-B1A0A9CC3D9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5" t="2403" r="1405" b="2678"/>
          <a:stretch/>
        </p:blipFill>
        <p:spPr>
          <a:xfrm>
            <a:off x="1552353" y="900223"/>
            <a:ext cx="4649973" cy="270067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5875A49-EF95-8249-ADB3-6080EE3742B2}"/>
              </a:ext>
            </a:extLst>
          </p:cNvPr>
          <p:cNvSpPr txBox="1"/>
          <p:nvPr/>
        </p:nvSpPr>
        <p:spPr>
          <a:xfrm>
            <a:off x="983832" y="4254519"/>
            <a:ext cx="660561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S6 Fig.</a:t>
            </a:r>
            <a:r>
              <a:rPr lang="ja-JP" altLang="en-US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Quantitative PCR of DE sRNA candidates and their putative </a:t>
            </a:r>
            <a:r>
              <a:rPr lang="en-US" altLang="ja-JP" sz="1200" b="1">
                <a:latin typeface="Times New Roman" charset="0"/>
                <a:ea typeface="Times New Roman" charset="0"/>
                <a:cs typeface="Times New Roman" charset="0"/>
              </a:rPr>
              <a:t>targets in</a:t>
            </a:r>
            <a:r>
              <a:rPr lang="en-US" altLang="ja-JP" sz="1200" b="1" i="1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b="1" i="1" dirty="0">
                <a:latin typeface="Times New Roman" charset="0"/>
                <a:ea typeface="Times New Roman" charset="0"/>
                <a:cs typeface="Times New Roman" charset="0"/>
              </a:rPr>
              <a:t>C. japonica.</a:t>
            </a: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 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Normalized expression level  in MS04 sample were arbitrarily set to 1. “qPCR” indicates sRNA expression level based on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qRT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-PCR and “CPM” indicates the relative expression level based on normalized count data obtained by high-throughput sequencing.</a:t>
            </a:r>
            <a:r>
              <a:rPr lang="ja-JP" alt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For the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qRT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PCR result, values are the mean of three technical replicates. Predicted target gene was cjIRX-9 for DEsRNA1 and DEsRNA2, and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cjSHT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for DEsRNA3.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C170304-6EDB-5740-9CAC-EBC4A641950B}"/>
              </a:ext>
            </a:extLst>
          </p:cNvPr>
          <p:cNvSpPr txBox="1"/>
          <p:nvPr/>
        </p:nvSpPr>
        <p:spPr>
          <a:xfrm rot="16200000">
            <a:off x="605175" y="1907182"/>
            <a:ext cx="15215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Relative expression </a:t>
            </a:r>
            <a:endParaRPr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89F0DE0C-61FF-F54E-BC0D-CE4D51E23E7E}"/>
              </a:ext>
            </a:extLst>
          </p:cNvPr>
          <p:cNvCxnSpPr>
            <a:cxnSpLocks/>
          </p:cNvCxnSpPr>
          <p:nvPr/>
        </p:nvCxnSpPr>
        <p:spPr>
          <a:xfrm>
            <a:off x="5041900" y="1013637"/>
            <a:ext cx="0" cy="1898515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4979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</TotalTime>
  <Words>91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3</cp:revision>
  <dcterms:created xsi:type="dcterms:W3CDTF">2018-02-23T05:33:29Z</dcterms:created>
  <dcterms:modified xsi:type="dcterms:W3CDTF">2018-02-23T08:13:22Z</dcterms:modified>
</cp:coreProperties>
</file>